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9" r:id="rId2"/>
    <p:sldId id="262" r:id="rId3"/>
    <p:sldId id="260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9" autoAdjust="0"/>
    <p:restoredTop sz="91304" autoAdjust="0"/>
  </p:normalViewPr>
  <p:slideViewPr>
    <p:cSldViewPr snapToGrid="0">
      <p:cViewPr varScale="1">
        <p:scale>
          <a:sx n="80" d="100"/>
          <a:sy n="80" d="100"/>
        </p:scale>
        <p:origin x="78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1C6872-773B-4494-91D7-715A30021764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DE1B09-F85C-474B-9831-0B0A7241E2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7560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EDE1B09-F85C-474B-9831-0B0A7241E26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6769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099E889-514A-08F5-A296-021B9C681D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3ADC27A5-B328-6132-A207-B6AEAFBF67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BB589AC-0D0B-C81A-E27B-79D14DF18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BD827F3-97CF-02EA-07F6-8B5DC14C2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859841E-3D56-B0E8-D7DE-8EF8A4DCA8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774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78365AF-899D-99B6-5ABF-2D061A50D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A9A739A-D616-FCD0-FC7E-2E213D7F64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23B8605-6789-1218-8F0B-21F9F35A5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BAB8239-3902-91F5-05F4-59E2C069C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ECBD1B8-8A9C-BCE2-9143-4C04770689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400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588BBAC1-1697-1102-AF3D-2715F41F0F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F4536DD-E832-83B5-78FB-489829E303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0621480-1315-A83C-E438-68CDDAC66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07A3D90-E651-6BDD-BAEA-3DD5A2B65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5215B13-21D7-056E-1D27-AEC08068D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202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10BC5F3-3F4A-1CCF-311D-899E47BA74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AC0D6EC-B406-957C-6A55-AEC42AD2DE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6ED5F72-C834-82F5-3F34-517C15072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C340F30-4602-8A32-4D3C-0F4F9FBAF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EB608CB-98BE-D276-AEDF-388FEA44DD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05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92DFDC5-A469-C07F-1DBE-F4B06B979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B391A2A-59CA-D4BF-FCA7-4759E326D8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E5C4470-5ADF-8970-0F1E-FD714D148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DA9C04E-89A8-8FA9-260D-67BCCF4F4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17B2EE3-8A50-C464-B673-117265B67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696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93AF9E-E641-CFD4-AA02-C4B7C4C1BC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D0AF1BE-1E67-608E-63B0-376E83E351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ECB3A71A-447C-C0CA-BFA3-1EA83A2028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5E1C9F7-BA5E-413F-3876-F58CDE443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0B6108C-5CD1-4201-6E93-A111BB76B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E2EDFBD-228D-4A9B-F260-C0DD32D1B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255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CD2B165-7D72-DA01-5179-9C642A87C0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E8255E11-C6E4-5A2A-F661-D817CDA5BC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0ED8F3F-DEB8-BFD0-6937-FB87A6871D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FBAB8EF4-3355-0837-AC5F-E966B900AE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2D07637-6139-BB9A-2ECB-1D1AE88247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0142CC5-09F4-6388-A284-229FD57C9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F101E345-12D3-5AA4-B15B-806B845BEC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94D8C8B4-0512-9A1F-4A64-5C6E19C4A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30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D4D9EA4-3E3F-1952-D56B-1CEA069349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A26994CD-5CB3-88A6-F5C0-6E1CBBC28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CC34A901-F914-A557-CBF4-811E68F86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15E0E6D5-ACAC-6306-35D0-68757646B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123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C83275E2-3347-0641-A589-8D75A2FE0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3A25AE88-EBD8-2D09-9D38-E2E4860A5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BFC3E286-6EF6-4F61-0D03-8617C0E25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947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DE61CDD-3CC0-9B95-D650-5CD7262D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6D7ECDC-86D1-BB82-4285-78780E4C76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73ED69E-BBAE-212E-750D-64A69D4F77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4F58D08-2911-9402-02F7-D88E6C78FD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44BEF20-C705-4177-3393-336EA58C2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6032192-31DE-0EAD-4AE2-BA0B6F0D8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291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D1B7C5D-BA11-5F68-6D54-EA0853A72F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FBA06AF6-B50C-B992-9233-553B38B8FA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8745235-3700-8760-027A-9928D6BA34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5C4C5C3-79FA-5244-45B4-BB4B663F1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8643917-BBC9-9F3C-233B-32C1AAA62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5EE6121-3E0E-3F70-F364-7D0DED651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105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DEEED62B-5E5B-D9BC-D217-7C60D227EE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7992668-A26D-C167-BB7A-463275E3FC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ED7135C-45D6-7FD9-1B65-46029AD85F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7EFD5-2F25-4B6D-976D-6736EAFFE472}" type="datetimeFigureOut">
              <a:rPr lang="en-US" smtClean="0"/>
              <a:t>4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4BBADE0-B2CD-185F-47E1-3D16BBFC23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6F79371-13E7-7C9F-7E73-9DA6A4613C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ED978-2167-4AA9-933F-537BC3184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529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FFF7A80B-A52D-2CA0-272E-C0EE14B19FF0}"/>
              </a:ext>
            </a:extLst>
          </p:cNvPr>
          <p:cNvSpPr txBox="1"/>
          <p:nvPr/>
        </p:nvSpPr>
        <p:spPr>
          <a:xfrm>
            <a:off x="433010" y="1988023"/>
            <a:ext cx="1301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22 CAR-T</a:t>
            </a:r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xmlns="" id="{7CD75936-E688-8CAC-D2BA-31DBF942940A}"/>
              </a:ext>
            </a:extLst>
          </p:cNvPr>
          <p:cNvSpPr/>
          <p:nvPr/>
        </p:nvSpPr>
        <p:spPr>
          <a:xfrm>
            <a:off x="1739970" y="2106688"/>
            <a:ext cx="634721" cy="14788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1913A9DD-61C0-A8A9-0965-A4E11313FA1D}"/>
              </a:ext>
            </a:extLst>
          </p:cNvPr>
          <p:cNvSpPr txBox="1"/>
          <p:nvPr/>
        </p:nvSpPr>
        <p:spPr>
          <a:xfrm>
            <a:off x="2440678" y="2003695"/>
            <a:ext cx="17315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4</a:t>
            </a:r>
            <a:r>
              <a:rPr lang="en-US" baseline="30000" dirty="0"/>
              <a:t>+</a:t>
            </a:r>
            <a:r>
              <a:rPr lang="en-US" dirty="0"/>
              <a:t>CD8</a:t>
            </a:r>
            <a:r>
              <a:rPr lang="en-US" baseline="30000" dirty="0"/>
              <a:t>+</a:t>
            </a:r>
            <a:r>
              <a:rPr lang="en-US" dirty="0"/>
              <a:t> T cell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AAFC9D1D-145D-02A8-00CE-D8F9D6B06826}"/>
              </a:ext>
            </a:extLst>
          </p:cNvPr>
          <p:cNvSpPr txBox="1"/>
          <p:nvPr/>
        </p:nvSpPr>
        <p:spPr>
          <a:xfrm>
            <a:off x="4295647" y="1665803"/>
            <a:ext cx="10508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imV, IL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CA7F612-906C-6EF0-C1C5-C16AD1164283}"/>
              </a:ext>
            </a:extLst>
          </p:cNvPr>
          <p:cNvSpPr txBox="1"/>
          <p:nvPr/>
        </p:nvSpPr>
        <p:spPr>
          <a:xfrm>
            <a:off x="5517155" y="1620483"/>
            <a:ext cx="1157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3/CD2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A2EA4E29-CD01-BDA4-7F0E-C6FBD57AAD16}"/>
              </a:ext>
            </a:extLst>
          </p:cNvPr>
          <p:cNvSpPr txBox="1"/>
          <p:nvPr/>
        </p:nvSpPr>
        <p:spPr>
          <a:xfrm>
            <a:off x="4560318" y="2379724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ag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xmlns="" id="{E9C5ED7E-756E-A150-945A-9B39AEB30D25}"/>
              </a:ext>
            </a:extLst>
          </p:cNvPr>
          <p:cNvCxnSpPr>
            <a:cxnSpLocks/>
          </p:cNvCxnSpPr>
          <p:nvPr/>
        </p:nvCxnSpPr>
        <p:spPr>
          <a:xfrm>
            <a:off x="5821076" y="2166446"/>
            <a:ext cx="5682857" cy="113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xmlns="" id="{A4A01EF8-C3AA-7FB6-A73B-225DA1761D01}"/>
              </a:ext>
            </a:extLst>
          </p:cNvPr>
          <p:cNvCxnSpPr>
            <a:cxnSpLocks/>
          </p:cNvCxnSpPr>
          <p:nvPr/>
        </p:nvCxnSpPr>
        <p:spPr>
          <a:xfrm>
            <a:off x="7122640" y="1981426"/>
            <a:ext cx="0" cy="36651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0BC8A29A-7538-338B-792C-90FE413F7DE1}"/>
              </a:ext>
            </a:extLst>
          </p:cNvPr>
          <p:cNvSpPr txBox="1"/>
          <p:nvPr/>
        </p:nvSpPr>
        <p:spPr>
          <a:xfrm>
            <a:off x="6992653" y="2421867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EF9AE9DD-026A-5870-FD44-AFDF8ED1BE9A}"/>
              </a:ext>
            </a:extLst>
          </p:cNvPr>
          <p:cNvSpPr txBox="1"/>
          <p:nvPr/>
        </p:nvSpPr>
        <p:spPr>
          <a:xfrm>
            <a:off x="6806404" y="1619072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R (L)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4CB9A234-EEFA-3B08-7D09-650504B1BD90}"/>
              </a:ext>
            </a:extLst>
          </p:cNvPr>
          <p:cNvCxnSpPr>
            <a:cxnSpLocks/>
          </p:cNvCxnSpPr>
          <p:nvPr/>
        </p:nvCxnSpPr>
        <p:spPr>
          <a:xfrm>
            <a:off x="8027649" y="2013214"/>
            <a:ext cx="0" cy="36651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16A3C957-16CE-7105-1600-59125AEE15BB}"/>
              </a:ext>
            </a:extLst>
          </p:cNvPr>
          <p:cNvSpPr txBox="1"/>
          <p:nvPr/>
        </p:nvSpPr>
        <p:spPr>
          <a:xfrm>
            <a:off x="7855290" y="2404832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CFB9DF22-AE59-75D3-736D-80B3785938A2}"/>
              </a:ext>
            </a:extLst>
          </p:cNvPr>
          <p:cNvSpPr txBox="1"/>
          <p:nvPr/>
        </p:nvSpPr>
        <p:spPr>
          <a:xfrm>
            <a:off x="7559989" y="1354804"/>
            <a:ext cx="8989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op TR</a:t>
            </a:r>
          </a:p>
          <a:p>
            <a:pPr algn="ctr"/>
            <a:r>
              <a:rPr lang="en-US" dirty="0"/>
              <a:t>CHM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xmlns="" id="{37ECFEC8-6593-DBBB-807B-E423E47CC7E8}"/>
              </a:ext>
            </a:extLst>
          </p:cNvPr>
          <p:cNvCxnSpPr>
            <a:cxnSpLocks/>
          </p:cNvCxnSpPr>
          <p:nvPr/>
        </p:nvCxnSpPr>
        <p:spPr>
          <a:xfrm>
            <a:off x="8886723" y="2013214"/>
            <a:ext cx="0" cy="36651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50F55341-12BF-373C-2408-7823322B85CB}"/>
              </a:ext>
            </a:extLst>
          </p:cNvPr>
          <p:cNvSpPr txBox="1"/>
          <p:nvPr/>
        </p:nvSpPr>
        <p:spPr>
          <a:xfrm>
            <a:off x="8655465" y="2404539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09431C0D-F9C8-E9F5-53EC-9408F3EC871C}"/>
              </a:ext>
            </a:extLst>
          </p:cNvPr>
          <p:cNvSpPr txBox="1"/>
          <p:nvPr/>
        </p:nvSpPr>
        <p:spPr>
          <a:xfrm>
            <a:off x="8441214" y="1342638"/>
            <a:ext cx="9124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ebead</a:t>
            </a:r>
          </a:p>
          <a:p>
            <a:pPr algn="ctr"/>
            <a:r>
              <a:rPr lang="en-US" dirty="0"/>
              <a:t>CH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F355D1B2-877B-1320-EAA1-14A641A28D8C}"/>
              </a:ext>
            </a:extLst>
          </p:cNvPr>
          <p:cNvSpPr txBox="1"/>
          <p:nvPr/>
        </p:nvSpPr>
        <p:spPr>
          <a:xfrm>
            <a:off x="10000288" y="2400072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3544565-889A-09D5-438D-CE55909D78BC}"/>
              </a:ext>
            </a:extLst>
          </p:cNvPr>
          <p:cNvSpPr txBox="1"/>
          <p:nvPr/>
        </p:nvSpPr>
        <p:spPr>
          <a:xfrm>
            <a:off x="9844537" y="1625336"/>
            <a:ext cx="649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M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xmlns="" id="{2DF80404-5D9A-0DB9-71B7-DD02D644CD91}"/>
              </a:ext>
            </a:extLst>
          </p:cNvPr>
          <p:cNvCxnSpPr>
            <a:cxnSpLocks/>
          </p:cNvCxnSpPr>
          <p:nvPr/>
        </p:nvCxnSpPr>
        <p:spPr>
          <a:xfrm>
            <a:off x="10237283" y="2013214"/>
            <a:ext cx="0" cy="36651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xmlns="" id="{9D22940D-404A-2B60-D350-C6E28EFC2D80}"/>
              </a:ext>
            </a:extLst>
          </p:cNvPr>
          <p:cNvCxnSpPr>
            <a:cxnSpLocks/>
          </p:cNvCxnSpPr>
          <p:nvPr/>
        </p:nvCxnSpPr>
        <p:spPr>
          <a:xfrm>
            <a:off x="10995164" y="2014010"/>
            <a:ext cx="0" cy="36491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17177B93-F938-110D-3545-0E9EDEB1A59D}"/>
              </a:ext>
            </a:extLst>
          </p:cNvPr>
          <p:cNvSpPr txBox="1"/>
          <p:nvPr/>
        </p:nvSpPr>
        <p:spPr>
          <a:xfrm>
            <a:off x="10600609" y="1616367"/>
            <a:ext cx="903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rves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13519DB0-3F3B-90E4-58EF-5295C99C92C7}"/>
              </a:ext>
            </a:extLst>
          </p:cNvPr>
          <p:cNvSpPr txBox="1"/>
          <p:nvPr/>
        </p:nvSpPr>
        <p:spPr>
          <a:xfrm>
            <a:off x="10772988" y="2409748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9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395EC934-0A2A-2998-E539-D3FC8CC736FD}"/>
              </a:ext>
            </a:extLst>
          </p:cNvPr>
          <p:cNvSpPr txBox="1"/>
          <p:nvPr/>
        </p:nvSpPr>
        <p:spPr>
          <a:xfrm>
            <a:off x="5857342" y="2413832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0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xmlns="" id="{F45F1A79-78E9-368F-F7E3-5066ECF31D5E}"/>
              </a:ext>
            </a:extLst>
          </p:cNvPr>
          <p:cNvCxnSpPr>
            <a:cxnSpLocks/>
          </p:cNvCxnSpPr>
          <p:nvPr/>
        </p:nvCxnSpPr>
        <p:spPr>
          <a:xfrm>
            <a:off x="6079518" y="1983191"/>
            <a:ext cx="0" cy="36651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Arrow: Right 26">
            <a:extLst>
              <a:ext uri="{FF2B5EF4-FFF2-40B4-BE49-F238E27FC236}">
                <a16:creationId xmlns:a16="http://schemas.microsoft.com/office/drawing/2014/main" xmlns="" id="{FC986DA5-77FE-F21B-8009-6D1F394F7706}"/>
              </a:ext>
            </a:extLst>
          </p:cNvPr>
          <p:cNvSpPr/>
          <p:nvPr/>
        </p:nvSpPr>
        <p:spPr>
          <a:xfrm>
            <a:off x="4319283" y="2106688"/>
            <a:ext cx="1177337" cy="13325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8F2E230A-9DAD-EBDC-DCD5-BF0DED2CA8DC}"/>
              </a:ext>
            </a:extLst>
          </p:cNvPr>
          <p:cNvSpPr txBox="1"/>
          <p:nvPr/>
        </p:nvSpPr>
        <p:spPr>
          <a:xfrm>
            <a:off x="398714" y="116769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378C960D-45F3-DC9E-0D6E-4645562606EC}"/>
              </a:ext>
            </a:extLst>
          </p:cNvPr>
          <p:cNvSpPr txBox="1"/>
          <p:nvPr/>
        </p:nvSpPr>
        <p:spPr>
          <a:xfrm>
            <a:off x="449040" y="3220526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)</a:t>
            </a:r>
            <a:endParaRPr lang="en-US" sz="14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355643B-26CA-DB08-C4BA-E6FFA95E97E6}"/>
              </a:ext>
            </a:extLst>
          </p:cNvPr>
          <p:cNvSpPr txBox="1"/>
          <p:nvPr/>
        </p:nvSpPr>
        <p:spPr>
          <a:xfrm>
            <a:off x="4879434" y="384943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S1</a:t>
            </a:r>
            <a:endParaRPr lang="en-US" b="1" dirty="0"/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xmlns="" id="{AB771D52-FDAE-E949-8B93-2B1A523C3D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4444" y="3220526"/>
            <a:ext cx="5526656" cy="3383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30107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5B368DC6-31BE-5362-8E04-8E1755AA3816}"/>
              </a:ext>
            </a:extLst>
          </p:cNvPr>
          <p:cNvSpPr txBox="1"/>
          <p:nvPr/>
        </p:nvSpPr>
        <p:spPr>
          <a:xfrm>
            <a:off x="374395" y="76657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)</a:t>
            </a:r>
          </a:p>
        </p:txBody>
      </p:sp>
      <p:pic>
        <p:nvPicPr>
          <p:cNvPr id="4" name="Picture 3" descr="A close-up of a diagram&#10;&#10;Description automatically generated">
            <a:extLst>
              <a:ext uri="{FF2B5EF4-FFF2-40B4-BE49-F238E27FC236}">
                <a16:creationId xmlns:a16="http://schemas.microsoft.com/office/drawing/2014/main" xmlns="" id="{36AC7127-C8E3-880E-BCE9-13ED49DA89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99" y="1290655"/>
            <a:ext cx="11972202" cy="1828800"/>
          </a:xfrm>
          <a:prstGeom prst="rect">
            <a:avLst/>
          </a:prstGeom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xmlns="" id="{8A46623B-ED54-B501-277A-FF4D33ECCDC3}"/>
              </a:ext>
            </a:extLst>
          </p:cNvPr>
          <p:cNvSpPr/>
          <p:nvPr/>
        </p:nvSpPr>
        <p:spPr>
          <a:xfrm>
            <a:off x="2074637" y="2165026"/>
            <a:ext cx="415204" cy="14788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xmlns="" id="{02588DFF-4A1A-A7B7-1641-103BD07CC218}"/>
              </a:ext>
            </a:extLst>
          </p:cNvPr>
          <p:cNvSpPr/>
          <p:nvPr/>
        </p:nvSpPr>
        <p:spPr>
          <a:xfrm>
            <a:off x="4571561" y="2165026"/>
            <a:ext cx="415204" cy="14788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xmlns="" id="{D9645B16-B021-0DC3-E32A-94C5783AB405}"/>
              </a:ext>
            </a:extLst>
          </p:cNvPr>
          <p:cNvSpPr/>
          <p:nvPr/>
        </p:nvSpPr>
        <p:spPr>
          <a:xfrm>
            <a:off x="7068485" y="2165026"/>
            <a:ext cx="415204" cy="14788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xmlns="" id="{4FF05EE1-235A-7671-C5F3-FE761819A09D}"/>
              </a:ext>
            </a:extLst>
          </p:cNvPr>
          <p:cNvSpPr/>
          <p:nvPr/>
        </p:nvSpPr>
        <p:spPr>
          <a:xfrm>
            <a:off x="9735123" y="2131115"/>
            <a:ext cx="415204" cy="14788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6913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1182D723-CE8A-1FAA-18D3-4406EE0AFAC4}"/>
              </a:ext>
            </a:extLst>
          </p:cNvPr>
          <p:cNvSpPr txBox="1"/>
          <p:nvPr/>
        </p:nvSpPr>
        <p:spPr>
          <a:xfrm>
            <a:off x="4569056" y="217144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S2</a:t>
            </a:r>
            <a:endParaRPr lang="en-US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697D9B03-500C-97F9-7CD2-1887667E1C62}"/>
              </a:ext>
            </a:extLst>
          </p:cNvPr>
          <p:cNvSpPr txBox="1"/>
          <p:nvPr/>
        </p:nvSpPr>
        <p:spPr>
          <a:xfrm>
            <a:off x="1615643" y="713713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5D141715-EC6B-4C9B-82CD-3E9E427B42D8}"/>
              </a:ext>
            </a:extLst>
          </p:cNvPr>
          <p:cNvSpPr txBox="1"/>
          <p:nvPr/>
        </p:nvSpPr>
        <p:spPr>
          <a:xfrm>
            <a:off x="6857214" y="713713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64260084-6F74-5E01-00D6-C3461168AD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1122" y="3114570"/>
            <a:ext cx="1613597" cy="35661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D27E3662-79A4-3157-E96E-0CA7D75F74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53092" y="713713"/>
            <a:ext cx="3290963" cy="2286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AC7916E7-79FB-7502-E56C-25DE6A380E4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45928" y="3114570"/>
            <a:ext cx="1505289" cy="35661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1C873B45-9991-31B2-4ED9-521D1960AC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30825" y="828570"/>
            <a:ext cx="3274192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60639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B44611B-D370-FC84-798A-F8BEC90D087C}"/>
              </a:ext>
            </a:extLst>
          </p:cNvPr>
          <p:cNvSpPr txBox="1"/>
          <p:nvPr/>
        </p:nvSpPr>
        <p:spPr>
          <a:xfrm>
            <a:off x="4569056" y="401289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S3</a:t>
            </a:r>
            <a:endParaRPr lang="en-US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D776D1CC-3EC4-BB41-162A-1F1A2A5CFA79}"/>
              </a:ext>
            </a:extLst>
          </p:cNvPr>
          <p:cNvSpPr txBox="1"/>
          <p:nvPr/>
        </p:nvSpPr>
        <p:spPr>
          <a:xfrm>
            <a:off x="1820822" y="152175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417E3663-B68A-8990-4D3B-80962EADF3AD}"/>
              </a:ext>
            </a:extLst>
          </p:cNvPr>
          <p:cNvSpPr txBox="1"/>
          <p:nvPr/>
        </p:nvSpPr>
        <p:spPr>
          <a:xfrm>
            <a:off x="6460050" y="1521758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2047B2A3-A44D-5F37-D105-01BCD95DC9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0041" y="1601618"/>
            <a:ext cx="8292155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5602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49</Words>
  <Application>Microsoft Office PowerPoint</Application>
  <PresentationFormat>Widescreen</PresentationFormat>
  <Paragraphs>29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a Prochazkova</dc:creator>
  <cp:lastModifiedBy>Rajalakshmi Thangaraj</cp:lastModifiedBy>
  <cp:revision>28</cp:revision>
  <dcterms:created xsi:type="dcterms:W3CDTF">2022-11-20T13:41:36Z</dcterms:created>
  <dcterms:modified xsi:type="dcterms:W3CDTF">2024-04-15T07:56:21Z</dcterms:modified>
</cp:coreProperties>
</file>